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530" r:id="rId2"/>
    <p:sldId id="513" r:id="rId3"/>
    <p:sldId id="526" r:id="rId4"/>
  </p:sldIdLst>
  <p:sldSz cx="6858000" cy="89884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6122"/>
  </p:normalViewPr>
  <p:slideViewPr>
    <p:cSldViewPr snapToGrid="0">
      <p:cViewPr varScale="1">
        <p:scale>
          <a:sx n="83" d="100"/>
          <a:sy n="83" d="100"/>
        </p:scale>
        <p:origin x="36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66B3B5-B16C-2B4C-98EF-D6E50C8921B2}" type="datetimeFigureOut">
              <a:rPr lang="en-US" smtClean="0"/>
              <a:t>6/2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1075" y="1143000"/>
            <a:ext cx="2355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5F37F2-7C6F-A247-8A65-86A69B2F46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343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l Figure 1. PTEN Knockout in mouse melanocytes</a:t>
            </a:r>
          </a:p>
          <a:p>
            <a:r>
              <a:rPr lang="en-US" dirty="0"/>
              <a:t>A. Immunoblot depicting PTEN expression in knockout cells vs. parental control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75F37F2-7C6F-A247-8A65-86A69B2F467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2376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51075" y="1143000"/>
            <a:ext cx="23558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RAC1</a:t>
            </a:r>
            <a:r>
              <a:rPr lang="en-US" sz="1800" b="1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29S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omotes cell cycle progression.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cycle profile was determined by propidium iodide staining followed by flow cytometry to analyze DNA content. Histogram Y-axis represents number of cells and X-axis represents DNA content as indicated by positive PI staining (left). Bar chat y-axis represents percent of cells in each cell cycle phase (x-axis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Quantitative time to exit mitosis. 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 value = 0.0088, calculated by two-tailed unpaired t-test, GraphPad Prism9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1FCA6D-05D7-456D-B3E1-5AFAC55C77D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2778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US" sz="1800" b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3.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K9 inhibition induces G2/M arrest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cent of cells in G2/M cell cycle phase determined by flow cytometry after 16 hours of drug treatment. Significance determined by 2way ANOVA, Tukey’s multiple comparisons test. P &lt; 0.0001 (****). P &lt; 0.001 (***). Not significant (</a:t>
            </a:r>
            <a:r>
              <a:rPr lang="en-US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.s</a:t>
            </a:r>
            <a:r>
              <a:rPr lang="en-US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).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naciclib 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.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VP2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E6998E-2959-1040-A11C-935D765FF5C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4261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8D4D6C-36AE-EEA2-5D99-8133C36F27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71023"/>
            <a:ext cx="5143500" cy="3129304"/>
          </a:xfrm>
        </p:spPr>
        <p:txBody>
          <a:bodyPr anchor="b"/>
          <a:lstStyle>
            <a:lvl1pPr algn="ctr">
              <a:defRPr sz="7864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01ABF0-4BB7-41C4-4F5E-3D384FFA47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721005"/>
            <a:ext cx="5143500" cy="2170121"/>
          </a:xfrm>
        </p:spPr>
        <p:txBody>
          <a:bodyPr/>
          <a:lstStyle>
            <a:lvl1pPr marL="0" indent="0" algn="ctr">
              <a:buNone/>
              <a:defRPr sz="3145"/>
            </a:lvl1pPr>
            <a:lvl2pPr marL="599206" indent="0" algn="ctr">
              <a:buNone/>
              <a:defRPr sz="2621"/>
            </a:lvl2pPr>
            <a:lvl3pPr marL="1198413" indent="0" algn="ctr">
              <a:buNone/>
              <a:defRPr sz="2359"/>
            </a:lvl3pPr>
            <a:lvl4pPr marL="1797619" indent="0" algn="ctr">
              <a:buNone/>
              <a:defRPr sz="2097"/>
            </a:lvl4pPr>
            <a:lvl5pPr marL="2396825" indent="0" algn="ctr">
              <a:buNone/>
              <a:defRPr sz="2097"/>
            </a:lvl5pPr>
            <a:lvl6pPr marL="2996032" indent="0" algn="ctr">
              <a:buNone/>
              <a:defRPr sz="2097"/>
            </a:lvl6pPr>
            <a:lvl7pPr marL="3595238" indent="0" algn="ctr">
              <a:buNone/>
              <a:defRPr sz="2097"/>
            </a:lvl7pPr>
            <a:lvl8pPr marL="4194444" indent="0" algn="ctr">
              <a:buNone/>
              <a:defRPr sz="2097"/>
            </a:lvl8pPr>
            <a:lvl9pPr marL="4793651" indent="0" algn="ctr">
              <a:buNone/>
              <a:defRPr sz="2097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A14DEA-E9E7-8BFB-0AED-3E4EE5F83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3309C5-3EA6-5506-6FE7-6046B2C9E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2BD177-CD0E-561F-D188-587D684A5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990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22B94-11E7-96C0-AA25-FDFB67CD75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EFE5BF-3D8E-F89E-6774-E263C2D729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628BE9-1117-08C5-E4E1-695B785338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A42F4B-4068-4620-5A0A-10421A8FF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E4E682-391D-30C4-E0F9-60D418F64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797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70281A-5E46-A1C2-93E9-45F57757CB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78550"/>
            <a:ext cx="1478756" cy="76172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7155A7-3469-A549-8C03-2932D2F867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78550"/>
            <a:ext cx="4350544" cy="76172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B7F5DB-7EE6-2E77-DB12-BB5839921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4BBD1B-CDFC-6214-B32C-84ECEB533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29A251-419C-AB96-C04E-D847C406B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20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3614A-FDCC-2E57-F1E6-7DDECDC4F8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76A726-903D-4A9F-A86E-2455E4360C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83B663-258F-CC91-C0AF-DE0CA9B1C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62C652-E496-1BC3-352C-C5027BDD0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82F2E5-EDBA-8808-77A1-A88ECF066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591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6D275F-C110-03B3-6C02-5344DF98B8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40866"/>
            <a:ext cx="5915025" cy="3738934"/>
          </a:xfrm>
        </p:spPr>
        <p:txBody>
          <a:bodyPr anchor="b"/>
          <a:lstStyle>
            <a:lvl1pPr>
              <a:defRPr sz="7864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8EFB52-ED54-B921-5F28-ABE614EFD3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015172"/>
            <a:ext cx="5915025" cy="1966217"/>
          </a:xfrm>
        </p:spPr>
        <p:txBody>
          <a:bodyPr/>
          <a:lstStyle>
            <a:lvl1pPr marL="0" indent="0">
              <a:buNone/>
              <a:defRPr sz="3145">
                <a:solidFill>
                  <a:schemeClr val="tx1">
                    <a:tint val="75000"/>
                  </a:schemeClr>
                </a:solidFill>
              </a:defRPr>
            </a:lvl1pPr>
            <a:lvl2pPr marL="599206" indent="0">
              <a:buNone/>
              <a:defRPr sz="2621">
                <a:solidFill>
                  <a:schemeClr val="tx1">
                    <a:tint val="75000"/>
                  </a:schemeClr>
                </a:solidFill>
              </a:defRPr>
            </a:lvl2pPr>
            <a:lvl3pPr marL="1198413" indent="0">
              <a:buNone/>
              <a:defRPr sz="2359">
                <a:solidFill>
                  <a:schemeClr val="tx1">
                    <a:tint val="75000"/>
                  </a:schemeClr>
                </a:solidFill>
              </a:defRPr>
            </a:lvl3pPr>
            <a:lvl4pPr marL="1797619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4pPr>
            <a:lvl5pPr marL="2396825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5pPr>
            <a:lvl6pPr marL="2996032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6pPr>
            <a:lvl7pPr marL="3595238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7pPr>
            <a:lvl8pPr marL="4194444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8pPr>
            <a:lvl9pPr marL="4793651" indent="0">
              <a:buNone/>
              <a:defRPr sz="20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0DEC13-6DF1-6E4C-053E-AFDB5FC7F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F1DC93-29BC-8293-5910-9FD4F0BCA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63C4E-090B-32BB-999D-B154560520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4367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E6420C-F3F7-85C5-498A-90E972C24D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86481A-EB3B-D37A-9FCA-3FBF739C9D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392752"/>
            <a:ext cx="2914650" cy="57030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5C545E-95D3-4CC5-B6D5-858A533366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392752"/>
            <a:ext cx="2914650" cy="57030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A69A7-71FB-D099-5252-09902C1AA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4B584B-7B83-24FF-FB9E-1237DD7BE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95F241-1B1E-B834-AD00-75E4C44EB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243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40BF55-6320-1B6A-278B-7BFB313D1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78551"/>
            <a:ext cx="5915025" cy="173734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0AFE91-7EDC-4235-F6DD-53ECC98E90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03413"/>
            <a:ext cx="2901255" cy="1079859"/>
          </a:xfrm>
        </p:spPr>
        <p:txBody>
          <a:bodyPr anchor="b"/>
          <a:lstStyle>
            <a:lvl1pPr marL="0" indent="0">
              <a:buNone/>
              <a:defRPr sz="3145" b="1"/>
            </a:lvl1pPr>
            <a:lvl2pPr marL="599206" indent="0">
              <a:buNone/>
              <a:defRPr sz="2621" b="1"/>
            </a:lvl2pPr>
            <a:lvl3pPr marL="1198413" indent="0">
              <a:buNone/>
              <a:defRPr sz="2359" b="1"/>
            </a:lvl3pPr>
            <a:lvl4pPr marL="1797619" indent="0">
              <a:buNone/>
              <a:defRPr sz="2097" b="1"/>
            </a:lvl4pPr>
            <a:lvl5pPr marL="2396825" indent="0">
              <a:buNone/>
              <a:defRPr sz="2097" b="1"/>
            </a:lvl5pPr>
            <a:lvl6pPr marL="2996032" indent="0">
              <a:buNone/>
              <a:defRPr sz="2097" b="1"/>
            </a:lvl6pPr>
            <a:lvl7pPr marL="3595238" indent="0">
              <a:buNone/>
              <a:defRPr sz="2097" b="1"/>
            </a:lvl7pPr>
            <a:lvl8pPr marL="4194444" indent="0">
              <a:buNone/>
              <a:defRPr sz="2097" b="1"/>
            </a:lvl8pPr>
            <a:lvl9pPr marL="4793651" indent="0">
              <a:buNone/>
              <a:defRPr sz="20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08F6C2-C090-B6F1-DBEF-A93BE16859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283272"/>
            <a:ext cx="2901255" cy="48291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E3FA5B-F22E-7EEA-DE73-F37703D4CA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03413"/>
            <a:ext cx="2915543" cy="1079859"/>
          </a:xfrm>
        </p:spPr>
        <p:txBody>
          <a:bodyPr anchor="b"/>
          <a:lstStyle>
            <a:lvl1pPr marL="0" indent="0">
              <a:buNone/>
              <a:defRPr sz="3145" b="1"/>
            </a:lvl1pPr>
            <a:lvl2pPr marL="599206" indent="0">
              <a:buNone/>
              <a:defRPr sz="2621" b="1"/>
            </a:lvl2pPr>
            <a:lvl3pPr marL="1198413" indent="0">
              <a:buNone/>
              <a:defRPr sz="2359" b="1"/>
            </a:lvl3pPr>
            <a:lvl4pPr marL="1797619" indent="0">
              <a:buNone/>
              <a:defRPr sz="2097" b="1"/>
            </a:lvl4pPr>
            <a:lvl5pPr marL="2396825" indent="0">
              <a:buNone/>
              <a:defRPr sz="2097" b="1"/>
            </a:lvl5pPr>
            <a:lvl6pPr marL="2996032" indent="0">
              <a:buNone/>
              <a:defRPr sz="2097" b="1"/>
            </a:lvl6pPr>
            <a:lvl7pPr marL="3595238" indent="0">
              <a:buNone/>
              <a:defRPr sz="2097" b="1"/>
            </a:lvl7pPr>
            <a:lvl8pPr marL="4194444" indent="0">
              <a:buNone/>
              <a:defRPr sz="2097" b="1"/>
            </a:lvl8pPr>
            <a:lvl9pPr marL="4793651" indent="0">
              <a:buNone/>
              <a:defRPr sz="20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815E4C1-1293-F3E6-C0B1-F43DB136F03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283272"/>
            <a:ext cx="2915543" cy="48291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2975FF-942F-9D60-2BC8-A5B31C0999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92B283-AEF8-F707-A78F-D6D8914D2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B0664A-1C41-9D7A-0ECC-BD1362F6F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3173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5A82A6-8293-5425-587B-34B38A627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47824B-E420-D8A3-03E7-255FAF2FE8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3F3F77-7F5F-B88A-786A-8BFBA95930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EE9AE9-9BFE-E274-E39F-3D367B1BB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472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75913B-CD54-1FDD-A484-3A07AF322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4A86A7-F81C-A337-471A-3DD552C90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332DCC-239B-A211-DDA6-C9980C6443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47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5E771E-4BE3-3AC3-7649-8E07F24D72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99228"/>
            <a:ext cx="2211883" cy="2097299"/>
          </a:xfrm>
        </p:spPr>
        <p:txBody>
          <a:bodyPr anchor="b"/>
          <a:lstStyle>
            <a:lvl1pPr>
              <a:defRPr sz="4194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E47D6B-155A-21F1-56F9-68C8E94549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294167"/>
            <a:ext cx="3471863" cy="6387608"/>
          </a:xfrm>
        </p:spPr>
        <p:txBody>
          <a:bodyPr/>
          <a:lstStyle>
            <a:lvl1pPr>
              <a:defRPr sz="4194"/>
            </a:lvl1pPr>
            <a:lvl2pPr>
              <a:defRPr sz="3670"/>
            </a:lvl2pPr>
            <a:lvl3pPr>
              <a:defRPr sz="3145"/>
            </a:lvl3pPr>
            <a:lvl4pPr>
              <a:defRPr sz="2621"/>
            </a:lvl4pPr>
            <a:lvl5pPr>
              <a:defRPr sz="2621"/>
            </a:lvl5pPr>
            <a:lvl6pPr>
              <a:defRPr sz="2621"/>
            </a:lvl6pPr>
            <a:lvl7pPr>
              <a:defRPr sz="2621"/>
            </a:lvl7pPr>
            <a:lvl8pPr>
              <a:defRPr sz="2621"/>
            </a:lvl8pPr>
            <a:lvl9pPr>
              <a:defRPr sz="262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3A124D-8CCB-8220-A816-969FE7D275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696527"/>
            <a:ext cx="2211883" cy="4995651"/>
          </a:xfrm>
        </p:spPr>
        <p:txBody>
          <a:bodyPr/>
          <a:lstStyle>
            <a:lvl1pPr marL="0" indent="0">
              <a:buNone/>
              <a:defRPr sz="2097"/>
            </a:lvl1pPr>
            <a:lvl2pPr marL="599206" indent="0">
              <a:buNone/>
              <a:defRPr sz="1835"/>
            </a:lvl2pPr>
            <a:lvl3pPr marL="1198413" indent="0">
              <a:buNone/>
              <a:defRPr sz="1573"/>
            </a:lvl3pPr>
            <a:lvl4pPr marL="1797619" indent="0">
              <a:buNone/>
              <a:defRPr sz="1311"/>
            </a:lvl4pPr>
            <a:lvl5pPr marL="2396825" indent="0">
              <a:buNone/>
              <a:defRPr sz="1311"/>
            </a:lvl5pPr>
            <a:lvl6pPr marL="2996032" indent="0">
              <a:buNone/>
              <a:defRPr sz="1311"/>
            </a:lvl6pPr>
            <a:lvl7pPr marL="3595238" indent="0">
              <a:buNone/>
              <a:defRPr sz="1311"/>
            </a:lvl7pPr>
            <a:lvl8pPr marL="4194444" indent="0">
              <a:buNone/>
              <a:defRPr sz="1311"/>
            </a:lvl8pPr>
            <a:lvl9pPr marL="4793651" indent="0">
              <a:buNone/>
              <a:defRPr sz="131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1D787F-ADE2-1A05-0FE1-A6F36D07E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916AA5B-4DD6-E58E-9BFC-205A3BE5B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B6E091-EBEC-BBBF-CDD7-12DFD0276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740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DE9893-A541-6051-D786-3EB6154EC0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99228"/>
            <a:ext cx="2211883" cy="2097299"/>
          </a:xfrm>
        </p:spPr>
        <p:txBody>
          <a:bodyPr anchor="b"/>
          <a:lstStyle>
            <a:lvl1pPr>
              <a:defRPr sz="4194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876192-D76D-220F-DFF5-3E11A7A961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294167"/>
            <a:ext cx="3471863" cy="6387608"/>
          </a:xfrm>
        </p:spPr>
        <p:txBody>
          <a:bodyPr/>
          <a:lstStyle>
            <a:lvl1pPr marL="0" indent="0">
              <a:buNone/>
              <a:defRPr sz="4194"/>
            </a:lvl1pPr>
            <a:lvl2pPr marL="599206" indent="0">
              <a:buNone/>
              <a:defRPr sz="3670"/>
            </a:lvl2pPr>
            <a:lvl3pPr marL="1198413" indent="0">
              <a:buNone/>
              <a:defRPr sz="3145"/>
            </a:lvl3pPr>
            <a:lvl4pPr marL="1797619" indent="0">
              <a:buNone/>
              <a:defRPr sz="2621"/>
            </a:lvl4pPr>
            <a:lvl5pPr marL="2396825" indent="0">
              <a:buNone/>
              <a:defRPr sz="2621"/>
            </a:lvl5pPr>
            <a:lvl6pPr marL="2996032" indent="0">
              <a:buNone/>
              <a:defRPr sz="2621"/>
            </a:lvl6pPr>
            <a:lvl7pPr marL="3595238" indent="0">
              <a:buNone/>
              <a:defRPr sz="2621"/>
            </a:lvl7pPr>
            <a:lvl8pPr marL="4194444" indent="0">
              <a:buNone/>
              <a:defRPr sz="2621"/>
            </a:lvl8pPr>
            <a:lvl9pPr marL="4793651" indent="0">
              <a:buNone/>
              <a:defRPr sz="2621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0AA4E6-FB0F-B59C-4A07-B11743A6E5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696527"/>
            <a:ext cx="2211883" cy="4995651"/>
          </a:xfrm>
        </p:spPr>
        <p:txBody>
          <a:bodyPr/>
          <a:lstStyle>
            <a:lvl1pPr marL="0" indent="0">
              <a:buNone/>
              <a:defRPr sz="2097"/>
            </a:lvl1pPr>
            <a:lvl2pPr marL="599206" indent="0">
              <a:buNone/>
              <a:defRPr sz="1835"/>
            </a:lvl2pPr>
            <a:lvl3pPr marL="1198413" indent="0">
              <a:buNone/>
              <a:defRPr sz="1573"/>
            </a:lvl3pPr>
            <a:lvl4pPr marL="1797619" indent="0">
              <a:buNone/>
              <a:defRPr sz="1311"/>
            </a:lvl4pPr>
            <a:lvl5pPr marL="2396825" indent="0">
              <a:buNone/>
              <a:defRPr sz="1311"/>
            </a:lvl5pPr>
            <a:lvl6pPr marL="2996032" indent="0">
              <a:buNone/>
              <a:defRPr sz="1311"/>
            </a:lvl6pPr>
            <a:lvl7pPr marL="3595238" indent="0">
              <a:buNone/>
              <a:defRPr sz="1311"/>
            </a:lvl7pPr>
            <a:lvl8pPr marL="4194444" indent="0">
              <a:buNone/>
              <a:defRPr sz="1311"/>
            </a:lvl8pPr>
            <a:lvl9pPr marL="4793651" indent="0">
              <a:buNone/>
              <a:defRPr sz="131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10089D-317D-3310-0E2D-A7963A9F6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841661-6ABA-05F7-BDBE-7398F557D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2384CD-D72D-98CC-9931-FF23E6111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230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E266F3-015A-2B35-1BD5-577FA809F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78551"/>
            <a:ext cx="5915025" cy="17373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1B64C1-420B-48D9-2314-7B4F58AF41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392752"/>
            <a:ext cx="5915025" cy="57030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D2A3FF-5DD9-E6EA-70BE-9CF51E3444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330939"/>
            <a:ext cx="1543050" cy="478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259F4-826B-ED45-AC79-4F50B6FF8314}" type="datetimeFigureOut">
              <a:rPr lang="en-US" smtClean="0"/>
              <a:t>6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61ECD3-36E8-1F68-1111-D61EECAAA9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330939"/>
            <a:ext cx="2314575" cy="478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CF21EF-F2F0-B94B-EEFB-967E3C01FF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330939"/>
            <a:ext cx="1543050" cy="4785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95F2E9-735D-6E41-A26D-47229383D6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275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198413" rtl="0" eaLnBrk="1" latinLnBrk="0" hangingPunct="1">
        <a:lnSpc>
          <a:spcPct val="90000"/>
        </a:lnSpc>
        <a:spcBef>
          <a:spcPct val="0"/>
        </a:spcBef>
        <a:buNone/>
        <a:defRPr sz="5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603" indent="-299603" algn="l" defTabSz="1198413" rtl="0" eaLnBrk="1" latinLnBrk="0" hangingPunct="1">
        <a:lnSpc>
          <a:spcPct val="90000"/>
        </a:lnSpc>
        <a:spcBef>
          <a:spcPts val="1311"/>
        </a:spcBef>
        <a:buFont typeface="Arial" panose="020B0604020202020204" pitchFamily="34" charset="0"/>
        <a:buChar char="•"/>
        <a:defRPr sz="3670" kern="1200">
          <a:solidFill>
            <a:schemeClr val="tx1"/>
          </a:solidFill>
          <a:latin typeface="+mn-lt"/>
          <a:ea typeface="+mn-ea"/>
          <a:cs typeface="+mn-cs"/>
        </a:defRPr>
      </a:lvl1pPr>
      <a:lvl2pPr marL="898809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3145" kern="1200">
          <a:solidFill>
            <a:schemeClr val="tx1"/>
          </a:solidFill>
          <a:latin typeface="+mn-lt"/>
          <a:ea typeface="+mn-ea"/>
          <a:cs typeface="+mn-cs"/>
        </a:defRPr>
      </a:lvl2pPr>
      <a:lvl3pPr marL="1498016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621" kern="1200">
          <a:solidFill>
            <a:schemeClr val="tx1"/>
          </a:solidFill>
          <a:latin typeface="+mn-lt"/>
          <a:ea typeface="+mn-ea"/>
          <a:cs typeface="+mn-cs"/>
        </a:defRPr>
      </a:lvl3pPr>
      <a:lvl4pPr marL="2097222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4pPr>
      <a:lvl5pPr marL="2696428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5pPr>
      <a:lvl6pPr marL="3295635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6pPr>
      <a:lvl7pPr marL="3894841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7pPr>
      <a:lvl8pPr marL="4494047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8pPr>
      <a:lvl9pPr marL="5093254" indent="-299603" algn="l" defTabSz="1198413" rtl="0" eaLnBrk="1" latinLnBrk="0" hangingPunct="1">
        <a:lnSpc>
          <a:spcPct val="90000"/>
        </a:lnSpc>
        <a:spcBef>
          <a:spcPts val="655"/>
        </a:spcBef>
        <a:buFont typeface="Arial" panose="020B0604020202020204" pitchFamily="34" charset="0"/>
        <a:buChar char="•"/>
        <a:defRPr sz="23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1pPr>
      <a:lvl2pPr marL="599206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2pPr>
      <a:lvl3pPr marL="1198413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3pPr>
      <a:lvl4pPr marL="1797619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4pPr>
      <a:lvl5pPr marL="2396825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5pPr>
      <a:lvl6pPr marL="2996032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6pPr>
      <a:lvl7pPr marL="3595238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7pPr>
      <a:lvl8pPr marL="4194444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8pPr>
      <a:lvl9pPr marL="4793651" algn="l" defTabSz="1198413" rtl="0" eaLnBrk="1" latinLnBrk="0" hangingPunct="1">
        <a:defRPr sz="23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emf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E40ED3-7178-0D1B-8DD7-8DEFE5FD9C32}"/>
              </a:ext>
            </a:extLst>
          </p:cNvPr>
          <p:cNvSpPr txBox="1"/>
          <p:nvPr/>
        </p:nvSpPr>
        <p:spPr>
          <a:xfrm>
            <a:off x="757646" y="470263"/>
            <a:ext cx="3623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. 1</a:t>
            </a:r>
          </a:p>
        </p:txBody>
      </p:sp>
      <p:pic>
        <p:nvPicPr>
          <p:cNvPr id="6" name="Picture 5" descr="A picture containing black, black and white, minimalist&#10;&#10;Description automatically generated">
            <a:extLst>
              <a:ext uri="{FF2B5EF4-FFF2-40B4-BE49-F238E27FC236}">
                <a16:creationId xmlns:a16="http://schemas.microsoft.com/office/drawing/2014/main" id="{2B13581C-9018-2DE7-9665-4AEADB948BF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47893" t="50000" r="38723" b="40709"/>
          <a:stretch/>
        </p:blipFill>
        <p:spPr>
          <a:xfrm>
            <a:off x="2216529" y="3387688"/>
            <a:ext cx="705397" cy="36933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pic>
        <p:nvPicPr>
          <p:cNvPr id="8" name="Picture 7" descr="A black dot on a white background&#10;&#10;Description automatically generated with low confidence">
            <a:extLst>
              <a:ext uri="{FF2B5EF4-FFF2-40B4-BE49-F238E27FC236}">
                <a16:creationId xmlns:a16="http://schemas.microsoft.com/office/drawing/2014/main" id="{A3B417A1-150F-250F-4278-040B552EC82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47587" t="47769" r="39029" b="42939"/>
          <a:stretch/>
        </p:blipFill>
        <p:spPr>
          <a:xfrm>
            <a:off x="2216530" y="2955298"/>
            <a:ext cx="705397" cy="369332"/>
          </a:xfrm>
          <a:prstGeom prst="rect">
            <a:avLst/>
          </a:prstGeom>
          <a:ln w="15875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925B96B-92E6-5720-AA75-AE8B1E03AB95}"/>
              </a:ext>
            </a:extLst>
          </p:cNvPr>
          <p:cNvSpPr txBox="1"/>
          <p:nvPr/>
        </p:nvSpPr>
        <p:spPr>
          <a:xfrm>
            <a:off x="1268597" y="2435887"/>
            <a:ext cx="294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36FFCBC-C103-9046-A98B-1CB9A2E2375C}"/>
              </a:ext>
            </a:extLst>
          </p:cNvPr>
          <p:cNvSpPr txBox="1"/>
          <p:nvPr/>
        </p:nvSpPr>
        <p:spPr>
          <a:xfrm>
            <a:off x="1667889" y="3024548"/>
            <a:ext cx="5486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TE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329D5A3-5084-75A2-B365-0F87C2F10806}"/>
              </a:ext>
            </a:extLst>
          </p:cNvPr>
          <p:cNvSpPr txBox="1"/>
          <p:nvPr/>
        </p:nvSpPr>
        <p:spPr>
          <a:xfrm>
            <a:off x="1475926" y="3456938"/>
            <a:ext cx="7406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05AF95-9CAE-DB72-C07C-A9A906DCFBCA}"/>
              </a:ext>
            </a:extLst>
          </p:cNvPr>
          <p:cNvSpPr txBox="1"/>
          <p:nvPr/>
        </p:nvSpPr>
        <p:spPr>
          <a:xfrm>
            <a:off x="2055230" y="2561148"/>
            <a:ext cx="6400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0EA2BB-44CC-CC2A-5F71-5C686224458D}"/>
              </a:ext>
            </a:extLst>
          </p:cNvPr>
          <p:cNvSpPr txBox="1"/>
          <p:nvPr/>
        </p:nvSpPr>
        <p:spPr>
          <a:xfrm>
            <a:off x="2567854" y="2490161"/>
            <a:ext cx="64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57BL/6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sgPte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14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2AA91D6-19CE-4D51-BCA6-31C4F8F37CCF}"/>
              </a:ext>
            </a:extLst>
          </p:cNvPr>
          <p:cNvSpPr txBox="1"/>
          <p:nvPr/>
        </p:nvSpPr>
        <p:spPr>
          <a:xfrm>
            <a:off x="120947" y="2658921"/>
            <a:ext cx="294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Content Placeholder 4">
            <a:extLst>
              <a:ext uri="{FF2B5EF4-FFF2-40B4-BE49-F238E27FC236}">
                <a16:creationId xmlns:a16="http://schemas.microsoft.com/office/drawing/2014/main" id="{93C288C5-150A-4814-A621-E5583D37271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510" t="21364" r="43016" b="8777"/>
          <a:stretch/>
        </p:blipFill>
        <p:spPr>
          <a:xfrm>
            <a:off x="98332" y="3277774"/>
            <a:ext cx="1928125" cy="201153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E54134C1-E511-41CE-8340-6F1A1E5F94AE}"/>
              </a:ext>
            </a:extLst>
          </p:cNvPr>
          <p:cNvSpPr txBox="1"/>
          <p:nvPr/>
        </p:nvSpPr>
        <p:spPr>
          <a:xfrm>
            <a:off x="4016510" y="2658921"/>
            <a:ext cx="2948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Content Placeholder 4">
            <a:extLst>
              <a:ext uri="{FF2B5EF4-FFF2-40B4-BE49-F238E27FC236}">
                <a16:creationId xmlns:a16="http://schemas.microsoft.com/office/drawing/2014/main" id="{46864532-9461-58A8-554F-E4FC5F5200E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0813" y="3200777"/>
            <a:ext cx="2351624" cy="21935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BCA6E1C-D3DB-0712-807E-B45E8D1CC687}"/>
              </a:ext>
            </a:extLst>
          </p:cNvPr>
          <p:cNvSpPr txBox="1"/>
          <p:nvPr/>
        </p:nvSpPr>
        <p:spPr>
          <a:xfrm>
            <a:off x="4380814" y="2883985"/>
            <a:ext cx="2597923" cy="3105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8" dirty="0">
                <a:latin typeface="Arial" panose="020B0604020202020204" pitchFamily="34" charset="0"/>
                <a:cs typeface="Arial" panose="020B0604020202020204" pitchFamily="34" charset="0"/>
              </a:rPr>
              <a:t>H2B-GFP Live Cell Imaging</a:t>
            </a:r>
          </a:p>
        </p:txBody>
      </p:sp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1917492B-A9D0-FB34-6073-08F6EEE7AC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8010" t="66619" r="5612" b="4091"/>
          <a:stretch/>
        </p:blipFill>
        <p:spPr>
          <a:xfrm>
            <a:off x="1921080" y="5065639"/>
            <a:ext cx="2351624" cy="8051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C7E81C8-C953-0504-DD34-876FEE5D9499}"/>
              </a:ext>
            </a:extLst>
          </p:cNvPr>
          <p:cNvSpPr txBox="1"/>
          <p:nvPr/>
        </p:nvSpPr>
        <p:spPr>
          <a:xfrm>
            <a:off x="911267" y="2883985"/>
            <a:ext cx="2023295" cy="3105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18" dirty="0">
                <a:latin typeface="Arial" panose="020B0604020202020204" pitchFamily="34" charset="0"/>
                <a:cs typeface="Arial" panose="020B0604020202020204" pitchFamily="34" charset="0"/>
              </a:rPr>
              <a:t>Cell Cycle Profile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17FA7E6-09B9-9BE8-CC49-E501202245A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59270" y="3277775"/>
            <a:ext cx="2075243" cy="172613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C487832-69D2-8C90-17E5-6D57BD78A28A}"/>
              </a:ext>
            </a:extLst>
          </p:cNvPr>
          <p:cNvSpPr txBox="1"/>
          <p:nvPr/>
        </p:nvSpPr>
        <p:spPr>
          <a:xfrm>
            <a:off x="757646" y="470263"/>
            <a:ext cx="36231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. 2</a:t>
            </a:r>
          </a:p>
        </p:txBody>
      </p:sp>
    </p:spTree>
    <p:extLst>
      <p:ext uri="{BB962C8B-B14F-4D97-AF65-F5344CB8AC3E}">
        <p14:creationId xmlns:p14="http://schemas.microsoft.com/office/powerpoint/2010/main" val="14690430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16C80B7-283F-221C-BC58-A7D9D41197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046835"/>
            <a:ext cx="3283923" cy="194665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E52EBA7-7B26-432E-EC2A-F10619C974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14760" y="3046835"/>
            <a:ext cx="3343749" cy="19519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1AE76F-8220-84EC-9687-B98E0D8DC370}"/>
              </a:ext>
            </a:extLst>
          </p:cNvPr>
          <p:cNvSpPr txBox="1"/>
          <p:nvPr/>
        </p:nvSpPr>
        <p:spPr>
          <a:xfrm flipH="1">
            <a:off x="115681" y="2655270"/>
            <a:ext cx="144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C44D0A1-79E2-C5C2-E241-065395054925}"/>
              </a:ext>
            </a:extLst>
          </p:cNvPr>
          <p:cNvSpPr txBox="1"/>
          <p:nvPr/>
        </p:nvSpPr>
        <p:spPr>
          <a:xfrm>
            <a:off x="3501951" y="2710520"/>
            <a:ext cx="144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E4F2D05-F6B1-717E-803A-E8FE9046F5F4}"/>
              </a:ext>
            </a:extLst>
          </p:cNvPr>
          <p:cNvSpPr txBox="1"/>
          <p:nvPr/>
        </p:nvSpPr>
        <p:spPr>
          <a:xfrm>
            <a:off x="692331" y="809897"/>
            <a:ext cx="37098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. 3</a:t>
            </a:r>
          </a:p>
        </p:txBody>
      </p:sp>
    </p:spTree>
    <p:extLst>
      <p:ext uri="{BB962C8B-B14F-4D97-AF65-F5344CB8AC3E}">
        <p14:creationId xmlns:p14="http://schemas.microsoft.com/office/powerpoint/2010/main" val="2799007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</TotalTime>
  <Words>208</Words>
  <Application>Microsoft Macintosh PowerPoint</Application>
  <PresentationFormat>Custom</PresentationFormat>
  <Paragraphs>26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non,Alexa</dc:creator>
  <cp:lastModifiedBy>Cannon,Alexa</cp:lastModifiedBy>
  <cp:revision>5</cp:revision>
  <dcterms:created xsi:type="dcterms:W3CDTF">2023-06-07T15:13:45Z</dcterms:created>
  <dcterms:modified xsi:type="dcterms:W3CDTF">2023-06-21T14:51:37Z</dcterms:modified>
</cp:coreProperties>
</file>